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5" autoAdjust="0"/>
    <p:restoredTop sz="94660"/>
  </p:normalViewPr>
  <p:slideViewPr>
    <p:cSldViewPr snapToGrid="0">
      <p:cViewPr varScale="1">
        <p:scale>
          <a:sx n="91" d="100"/>
          <a:sy n="91" d="100"/>
        </p:scale>
        <p:origin x="8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759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1547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2400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990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9536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901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111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8871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6956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138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2011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555657-2B01-406F-A40C-D57FA398EF0E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64FC8-0F76-440D-B381-38B2AA2BE9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4166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4737348"/>
              </p:ext>
            </p:extLst>
          </p:nvPr>
        </p:nvGraphicFramePr>
        <p:xfrm>
          <a:off x="179448" y="788893"/>
          <a:ext cx="8685420" cy="4570501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331949"/>
                <a:gridCol w="1331949"/>
                <a:gridCol w="1331949"/>
                <a:gridCol w="1331949"/>
                <a:gridCol w="2025675"/>
                <a:gridCol w="1331949"/>
              </a:tblGrid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 err="1">
                          <a:effectLst/>
                        </a:rPr>
                        <a:t>P</a:t>
                      </a:r>
                      <a:r>
                        <a:rPr lang="en-US" sz="1400" b="1" u="none" strike="noStrike" dirty="0" err="1" smtClean="0">
                          <a:effectLst/>
                        </a:rPr>
                        <a:t>robeID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BET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S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P_VAL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 smtClean="0">
                          <a:effectLst/>
                        </a:rPr>
                        <a:t>Nearest gen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1589929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2268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814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2.74E-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012872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PRKAR1B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56395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2548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642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4.07E-0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0955433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WIPI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1951623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23429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43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1.30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1761883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TXNRD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1584011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1900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61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1.50E-0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1761883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SDK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2179881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1908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691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2.33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02187253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SULF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510313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1048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2060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3.59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02808691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SMYD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501948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0984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194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4.38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294223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CREB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498821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26476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5291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5.63E-0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302821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HOTTI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2200711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14150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2840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6.33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302821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CRHR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01627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2141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324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7.36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458471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MARC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905982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2008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101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9.70E-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14471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ALL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1397234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2357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839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1.11E-0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326706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EVX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2399337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2336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8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1.26E-0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326706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UBQLN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55162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-0.3773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7793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1.29E-0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326706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ZDHHC2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1577173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19988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14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1.40E-0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0.04391179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PRIM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68853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g0763053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16812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3497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1.54E-0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</a:rPr>
                        <a:t>0.04509344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355" marR="7355" marT="73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HRH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7084" y="185057"/>
            <a:ext cx="90569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Supplementary file S5</a:t>
            </a:r>
            <a:r>
              <a:rPr lang="en-GB" sz="1600" b="1" dirty="0" smtClean="0"/>
              <a:t>. </a:t>
            </a:r>
            <a:r>
              <a:rPr lang="en-GB" sz="1600" b="1" dirty="0" smtClean="0"/>
              <a:t>List of significant DMPs (FDR &lt; 0.05) from the Recurrent vs Low AF adjusted model </a:t>
            </a:r>
            <a:endParaRPr lang="en-GB" sz="1600" b="1" dirty="0"/>
          </a:p>
        </p:txBody>
      </p:sp>
    </p:spTree>
    <p:extLst>
      <p:ext uri="{BB962C8B-B14F-4D97-AF65-F5344CB8AC3E}">
        <p14:creationId xmlns:p14="http://schemas.microsoft.com/office/powerpoint/2010/main" val="1878996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33</Words>
  <Application>Microsoft Macintosh PowerPoint</Application>
  <PresentationFormat>On-screen Show (4:3)</PresentationFormat>
  <Paragraphs>10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>IARC</Company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ram Ghantous</dc:creator>
  <cp:lastModifiedBy>Michael Routledge</cp:lastModifiedBy>
  <cp:revision>5</cp:revision>
  <dcterms:created xsi:type="dcterms:W3CDTF">2020-03-13T18:42:49Z</dcterms:created>
  <dcterms:modified xsi:type="dcterms:W3CDTF">2021-03-25T16:15:52Z</dcterms:modified>
</cp:coreProperties>
</file>